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52886-FD14-48C7-96A6-5BDA50C334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8FC36-D174-4E25-908F-E84AB74D20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52AE2-C26F-48A6-BAAC-B61B3FCBF1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9A4B92-58D2-4EA5-B185-90955D6EAD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847C0-9AFB-468D-A1BD-4317653F1B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44439D-E1A7-4893-98D8-0F725A81D5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5EBE1-CEA4-4F0F-AEE0-CC32847054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FA9D3-A720-4E8A-B004-9649C36E39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B2818-D5D9-4396-9B97-5480E5FC2B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ABB25-C79C-4FF5-BC67-75EDE97173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F7A0F-C858-40B4-B333-23B0118EB8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3352D-1663-4533-9BE3-0827D33C2E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D8A029-6BAB-4181-B4D9-5A3175135E62}" type="slidenum">
              <a:rPr b="0" lang="pl-PL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a 1"/>
          <p:cNvGrpSpPr/>
          <p:nvPr/>
        </p:nvGrpSpPr>
        <p:grpSpPr>
          <a:xfrm>
            <a:off x="681120" y="1370160"/>
            <a:ext cx="5514840" cy="7412040"/>
            <a:chOff x="681120" y="1370160"/>
            <a:chExt cx="5514840" cy="7412040"/>
          </a:xfrm>
        </p:grpSpPr>
        <p:pic>
          <p:nvPicPr>
            <p:cNvPr id="42" name="Obraz 3" descr=""/>
            <p:cNvPicPr/>
            <p:nvPr/>
          </p:nvPicPr>
          <p:blipFill>
            <a:blip r:embed="rId1"/>
            <a:stretch/>
          </p:blipFill>
          <p:spPr>
            <a:xfrm>
              <a:off x="681120" y="4435560"/>
              <a:ext cx="5514840" cy="434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Obraz 4" descr=""/>
            <p:cNvPicPr/>
            <p:nvPr/>
          </p:nvPicPr>
          <p:blipFill>
            <a:blip r:embed="rId2"/>
            <a:stretch/>
          </p:blipFill>
          <p:spPr>
            <a:xfrm>
              <a:off x="681120" y="1739880"/>
              <a:ext cx="5496120" cy="2154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pole tekstowe 5"/>
            <p:cNvSpPr/>
            <p:nvPr/>
          </p:nvSpPr>
          <p:spPr>
            <a:xfrm>
              <a:off x="689040" y="1370160"/>
              <a:ext cx="313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pole tekstowe 6"/>
            <p:cNvSpPr/>
            <p:nvPr/>
          </p:nvSpPr>
          <p:spPr>
            <a:xfrm>
              <a:off x="690840" y="4070520"/>
              <a:ext cx="30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" name="pole tekstowe 7"/>
          <p:cNvSpPr/>
          <p:nvPr/>
        </p:nvSpPr>
        <p:spPr>
          <a:xfrm>
            <a:off x="312840" y="274680"/>
            <a:ext cx="636264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</a:t>
            </a:r>
            <a:r>
              <a:rPr b="0" lang="pl-PL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Serum humoral response in individual mice (A) and chickens (B) after immunization with the indicated vaccine plasmids with (+L) and without (-L) lipofectin. The scheme of immunization was as indicated in Figure 1. Animals obtained two doses of the vaccine: mice - 10 </a:t>
            </a:r>
            <a:r>
              <a:rPr b="0" lang="el-G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pl-PL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 of plasmid DNA per dose; chickens - 60 </a:t>
            </a:r>
            <a:r>
              <a:rPr b="0" lang="el-G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pl-PL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 of plasmid DNA per dose. The results of ELISA using 100-fold diluted serum are shown for mice. The results of ELISA (200-fold diluted serum) and the HI titer (log2) are shown for chickens. Lipofectin improves the level of the response and reduces the individual differences within the groups. The (-L)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5T19:10:05Z</dcterms:created>
  <dc:creator>agn</dc:creator>
  <dc:description/>
  <dc:language>en-US</dc:language>
  <cp:lastModifiedBy>Agnieszka Sirko</cp:lastModifiedBy>
  <dcterms:modified xsi:type="dcterms:W3CDTF">2016-07-28T13:38:34Z</dcterms:modified>
  <cp:revision>7</cp:revision>
  <dc:subject/>
  <dc:title>Prezentacja programu PowerPoint</dc:title>
</cp:coreProperties>
</file>